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77" r:id="rId2"/>
    <p:sldId id="278" r:id="rId3"/>
    <p:sldId id="279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48" autoAdjust="0"/>
    <p:restoredTop sz="93889" autoAdjust="0"/>
  </p:normalViewPr>
  <p:slideViewPr>
    <p:cSldViewPr snapToGrid="0">
      <p:cViewPr varScale="1">
        <p:scale>
          <a:sx n="104" d="100"/>
          <a:sy n="104" d="100"/>
        </p:scale>
        <p:origin x="6906" y="12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25766-C0FB-4FAD-AC56-C6577F1E0B5F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2EF1C2-FB5A-45B6-8E94-937912646E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3842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093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062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9548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4049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1106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7712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4400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9018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075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0553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9093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2451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>
            <a:extLst>
              <a:ext uri="{FF2B5EF4-FFF2-40B4-BE49-F238E27FC236}">
                <a16:creationId xmlns:a16="http://schemas.microsoft.com/office/drawing/2014/main" id="{547B24ED-CDD5-44FD-B3F3-2B0624EDDEF5}"/>
              </a:ext>
            </a:extLst>
          </p:cNvPr>
          <p:cNvGrpSpPr/>
          <p:nvPr/>
        </p:nvGrpSpPr>
        <p:grpSpPr>
          <a:xfrm>
            <a:off x="668018" y="865621"/>
            <a:ext cx="5438956" cy="7983512"/>
            <a:chOff x="668018" y="273950"/>
            <a:chExt cx="5438956" cy="7983512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6F081635-778B-4201-AA83-A43BCB1DFC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117" b="7720"/>
            <a:stretch/>
          </p:blipFill>
          <p:spPr>
            <a:xfrm>
              <a:off x="1122630" y="5477346"/>
              <a:ext cx="4825497" cy="2553077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BD832C19-1994-4FA3-A7BA-A0679EDC65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259" b="7720"/>
            <a:stretch/>
          </p:blipFill>
          <p:spPr>
            <a:xfrm>
              <a:off x="1077362" y="443620"/>
              <a:ext cx="4852658" cy="4427144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9935F502-5FD9-46DB-A835-F2317BAC7292}"/>
                </a:ext>
              </a:extLst>
            </p:cNvPr>
            <p:cNvSpPr txBox="1"/>
            <p:nvPr/>
          </p:nvSpPr>
          <p:spPr>
            <a:xfrm>
              <a:off x="2051913" y="273950"/>
              <a:ext cx="3421477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annotated in oxidative phosphorylation pathway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4AC8D6B7-9698-48A0-B321-79CB046FDD36}"/>
                </a:ext>
              </a:extLst>
            </p:cNvPr>
            <p:cNvSpPr txBox="1"/>
            <p:nvPr/>
          </p:nvSpPr>
          <p:spPr>
            <a:xfrm>
              <a:off x="668018" y="362622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22DE4350-2C5E-4CB3-9854-F431C4C04435}"/>
                </a:ext>
              </a:extLst>
            </p:cNvPr>
            <p:cNvSpPr txBox="1"/>
            <p:nvPr/>
          </p:nvSpPr>
          <p:spPr>
            <a:xfrm>
              <a:off x="1763025" y="4859111"/>
              <a:ext cx="39421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0min              R1min              R30min            R45min                R6h                 R1d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4B51A7FE-B119-4CD6-9554-75DC3503B259}"/>
                </a:ext>
              </a:extLst>
            </p:cNvPr>
            <p:cNvSpPr txBox="1"/>
            <p:nvPr/>
          </p:nvSpPr>
          <p:spPr>
            <a:xfrm>
              <a:off x="1418327" y="5301667"/>
              <a:ext cx="4688647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annotated in glycolysis/gluconeogenesis pathway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9041BDCA-3A34-408A-A3EF-01A51F665BAC}"/>
                </a:ext>
              </a:extLst>
            </p:cNvPr>
            <p:cNvSpPr txBox="1"/>
            <p:nvPr/>
          </p:nvSpPr>
          <p:spPr>
            <a:xfrm>
              <a:off x="668018" y="5421415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F2B73D39-A8BE-4D47-A929-BDCADF4EBA72}"/>
                </a:ext>
              </a:extLst>
            </p:cNvPr>
            <p:cNvSpPr txBox="1"/>
            <p:nvPr/>
          </p:nvSpPr>
          <p:spPr>
            <a:xfrm>
              <a:off x="1791597" y="8042018"/>
              <a:ext cx="39421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0min              R1min              R30min            R45min                R6h                 R1d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932590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组合 13">
            <a:extLst>
              <a:ext uri="{FF2B5EF4-FFF2-40B4-BE49-F238E27FC236}">
                <a16:creationId xmlns:a16="http://schemas.microsoft.com/office/drawing/2014/main" id="{E4848319-1117-4C9E-A9A1-6B8571CA3626}"/>
              </a:ext>
            </a:extLst>
          </p:cNvPr>
          <p:cNvGrpSpPr/>
          <p:nvPr/>
        </p:nvGrpSpPr>
        <p:grpSpPr>
          <a:xfrm>
            <a:off x="687068" y="154091"/>
            <a:ext cx="5324433" cy="7666385"/>
            <a:chOff x="687068" y="154091"/>
            <a:chExt cx="5324433" cy="7666385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410BC762-92E0-4A1E-9234-5E567BCF17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117" b="9135"/>
            <a:stretch/>
          </p:blipFill>
          <p:spPr>
            <a:xfrm>
              <a:off x="1167897" y="3892990"/>
              <a:ext cx="4843604" cy="3720974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14D35403-7214-4884-9A45-6D45F86506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259" b="7579"/>
            <a:stretch/>
          </p:blipFill>
          <p:spPr>
            <a:xfrm>
              <a:off x="1158844" y="322146"/>
              <a:ext cx="4789284" cy="3100064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47D022C8-2AB5-40D4-922B-08BDEF8538E8}"/>
                </a:ext>
              </a:extLst>
            </p:cNvPr>
            <p:cNvSpPr txBox="1"/>
            <p:nvPr/>
          </p:nvSpPr>
          <p:spPr>
            <a:xfrm>
              <a:off x="2063543" y="154091"/>
              <a:ext cx="3478972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annotated in tricarboxylic acid  pathway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366C53D0-BADA-460D-882A-7777B07000AE}"/>
                </a:ext>
              </a:extLst>
            </p:cNvPr>
            <p:cNvSpPr txBox="1"/>
            <p:nvPr/>
          </p:nvSpPr>
          <p:spPr>
            <a:xfrm>
              <a:off x="687068" y="217387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BF68D4E1-52EB-441F-9C21-CC4CFFDF693A}"/>
                </a:ext>
              </a:extLst>
            </p:cNvPr>
            <p:cNvSpPr txBox="1"/>
            <p:nvPr/>
          </p:nvSpPr>
          <p:spPr>
            <a:xfrm>
              <a:off x="1854498" y="3416367"/>
              <a:ext cx="39421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0min              R1min             R30min            R45min                R6h                 R1d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5CF83655-08B1-4247-A20B-2C9781813BCD}"/>
                </a:ext>
              </a:extLst>
            </p:cNvPr>
            <p:cNvSpPr txBox="1"/>
            <p:nvPr/>
          </p:nvSpPr>
          <p:spPr>
            <a:xfrm>
              <a:off x="2038436" y="3698571"/>
              <a:ext cx="361687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annotated in GO terms related to mitochondria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82E9D1DD-820D-4126-B5C0-87426E48AA19}"/>
                </a:ext>
              </a:extLst>
            </p:cNvPr>
            <p:cNvSpPr txBox="1"/>
            <p:nvPr/>
          </p:nvSpPr>
          <p:spPr>
            <a:xfrm>
              <a:off x="687068" y="3675488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6993C243-F1F1-43B9-B4C1-B55F95AA3B4D}"/>
                </a:ext>
              </a:extLst>
            </p:cNvPr>
            <p:cNvSpPr txBox="1"/>
            <p:nvPr/>
          </p:nvSpPr>
          <p:spPr>
            <a:xfrm>
              <a:off x="1836134" y="7605032"/>
              <a:ext cx="39421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0min              R1min              R30min            R45min                R6h                 R1d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485497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941B3917-1A58-45B5-A108-6925282552D5}"/>
              </a:ext>
            </a:extLst>
          </p:cNvPr>
          <p:cNvGrpSpPr/>
          <p:nvPr/>
        </p:nvGrpSpPr>
        <p:grpSpPr>
          <a:xfrm>
            <a:off x="669851" y="468024"/>
            <a:ext cx="5214901" cy="3442442"/>
            <a:chOff x="669851" y="468024"/>
            <a:chExt cx="5214901" cy="3442442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75D450B0-81E1-440D-8562-00ED0A70F0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542" b="9135"/>
            <a:stretch/>
          </p:blipFill>
          <p:spPr>
            <a:xfrm>
              <a:off x="1104523" y="639018"/>
              <a:ext cx="4780229" cy="3081956"/>
            </a:xfrm>
            <a:prstGeom prst="rect">
              <a:avLst/>
            </a:prstGeom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844C6D15-22E2-44B0-9D80-07C1B73A98EE}"/>
                </a:ext>
              </a:extLst>
            </p:cNvPr>
            <p:cNvSpPr txBox="1"/>
            <p:nvPr/>
          </p:nvSpPr>
          <p:spPr>
            <a:xfrm>
              <a:off x="2015885" y="468024"/>
              <a:ext cx="3478972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annotated coding components vacuolar type ATPases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E3AAA0F5-D8BF-4FDA-969D-14CD2BC3D37D}"/>
                </a:ext>
              </a:extLst>
            </p:cNvPr>
            <p:cNvSpPr txBox="1"/>
            <p:nvPr/>
          </p:nvSpPr>
          <p:spPr>
            <a:xfrm>
              <a:off x="669851" y="517385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E87D73EF-0853-426F-A263-2C007292D4A0}"/>
                </a:ext>
              </a:extLst>
            </p:cNvPr>
            <p:cNvSpPr txBox="1"/>
            <p:nvPr/>
          </p:nvSpPr>
          <p:spPr>
            <a:xfrm>
              <a:off x="1784319" y="3695022"/>
              <a:ext cx="39421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0min              R1min             R30min            R45min                R6h                 R1d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" name="文本框 7">
            <a:extLst>
              <a:ext uri="{FF2B5EF4-FFF2-40B4-BE49-F238E27FC236}">
                <a16:creationId xmlns:a16="http://schemas.microsoft.com/office/drawing/2014/main" id="{DA999C07-9796-460C-AE57-F3202949A1BC}"/>
              </a:ext>
            </a:extLst>
          </p:cNvPr>
          <p:cNvSpPr txBox="1"/>
          <p:nvPr/>
        </p:nvSpPr>
        <p:spPr>
          <a:xfrm>
            <a:off x="246706" y="4114461"/>
            <a:ext cx="6495861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10. Relative expression of levels of </a:t>
            </a:r>
            <a:r>
              <a:rPr lang="en-US" altLang="zh-CN" sz="1200" b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encoding proteins related to energy metabolism and mitochondrial components during rehydration in </a:t>
            </a:r>
            <a:r>
              <a:rPr lang="en-US" altLang="zh-CN" sz="12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. </a:t>
            </a:r>
            <a:r>
              <a:rPr lang="en-US" altLang="zh-CN" sz="1200" b="1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2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eatmap representation of gene expression along the oxidative phosphorylation pathway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; glycolysis/gluconeogenesis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; the tricarboxylic acid pathway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; </a:t>
            </a:r>
            <a:r>
              <a:rPr lang="en-US" altLang="zh-CN" sz="12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related to mitochondria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; vacuolar-type ATPases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E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058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71</TotalTime>
  <Words>132</Words>
  <Application>Microsoft Office PowerPoint</Application>
  <PresentationFormat>A4 纸张(210x297 毫米)</PresentationFormat>
  <Paragraphs>16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 Tianyi</dc:creator>
  <cp:lastModifiedBy>Ma Tianyi</cp:lastModifiedBy>
  <cp:revision>219</cp:revision>
  <dcterms:created xsi:type="dcterms:W3CDTF">2021-01-19T12:49:28Z</dcterms:created>
  <dcterms:modified xsi:type="dcterms:W3CDTF">2023-01-10T11:15:42Z</dcterms:modified>
</cp:coreProperties>
</file>